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509039-ECD8-4860-BE56-DC856B42A71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ijdelijke aanduiding voor dianumm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AF3FCA-A88E-40CF-9053-B8A88E51D4D8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C9902-BD3D-47BD-9AA2-4227192122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583B9-8C9D-447B-AB6C-E07ECAC472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4848BC-B1C6-4E7A-8EA9-E1C3071569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E2FDDA-1CA2-4212-87AF-7701B9DBFE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6A80CF-9CA8-4FCC-8D07-DC2B5CAA2B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76D320-B933-4AC9-B6A8-E5FEAD49F3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79EA28-EE5A-4C24-973F-FCB91B59A9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694F4-E334-47FB-BBFB-2CBB259E90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6740A-D885-4B74-80FF-2D1133EA11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19C2B9-36E0-4B9B-A743-E5C76472BB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1001CA-5369-47EF-8241-58DB20E038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B2DB6-C864-45F4-9E8F-57497AEA61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DD9F7B-C2F6-4352-8E54-DC5C1A1F2E0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44"/>
          <p:cNvSpPr/>
          <p:nvPr/>
        </p:nvSpPr>
        <p:spPr>
          <a:xfrm>
            <a:off x="128520" y="7148520"/>
            <a:ext cx="6597720" cy="179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.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he DGGE profiles of the total bacterial (A) and bifidobacterial community (B) on day 22 and 29 in the luminal (L) and mucosal (M) compartments. Further, samples are named with M or L depending on the colon reactor as described in Figure 3 for control,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Lactobacillus reuteri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, IN and LC-AX.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AIEC was inoculated on day 22, 23, 24 and 25. (b1 – </a:t>
            </a:r>
            <a:r>
              <a:rPr b="0" i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Bifidobacterium longum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; b2 – </a:t>
            </a:r>
            <a:r>
              <a:rPr b="0" i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Bifidobacterium bifidum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; b3 – </a:t>
            </a:r>
            <a:r>
              <a:rPr b="0" i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Bifidobacterium adolescentis).</a:t>
            </a: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1" descr=""/>
          <p:cNvPicPr/>
          <p:nvPr/>
        </p:nvPicPr>
        <p:blipFill>
          <a:blip r:embed="rId1"/>
          <a:stretch/>
        </p:blipFill>
        <p:spPr>
          <a:xfrm>
            <a:off x="673200" y="395280"/>
            <a:ext cx="5564160" cy="6686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9-16T07:43:07Z</dcterms:created>
  <dc:creator>Pieter</dc:creator>
  <dc:description/>
  <dc:language>en-US</dc:language>
  <cp:lastModifiedBy>Massimo Marzorati</cp:lastModifiedBy>
  <dcterms:modified xsi:type="dcterms:W3CDTF">2016-05-16T13:14:54Z</dcterms:modified>
  <cp:revision>8</cp:revision>
  <dc:subject/>
  <dc:title>Dia 1</dc:title>
</cp:coreProperties>
</file>